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9B8F0-9776-4BEB-B694-71D89B325C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56824-CE02-4F9B-A6FD-A3FE1680F2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AE68A-9059-4903-8E25-24010D6263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44B62-0282-4BD3-AA50-9F63C7C791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A60BB-D5E3-4F89-A958-7D2B9D6BFE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8E374-F94C-47BF-8C53-D82DE4E36A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EEFBE-946B-4BCC-BC01-72A2DCFB06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2D339-76C2-48D2-A0A3-7CE8C645D1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B7763-E780-42A0-912D-8A66E75724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664B9-C8C4-4972-AA91-D0C94E96C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7D01C-EDF6-4A57-A7F7-922AEF4674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46D30-F9E2-4584-8F3C-CB9EB01ED9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431302-1243-4E68-A4E4-C75C8E23BEC6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C29711-4227-47B3-A23A-9C8250123EB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2280" y="380880"/>
          <a:ext cx="6553440" cy="8534520"/>
        </p:xfrm>
        <a:graphic>
          <a:graphicData uri="http://schemas.openxmlformats.org/drawingml/2006/table">
            <a:tbl>
              <a:tblPr/>
              <a:tblGrid>
                <a:gridCol w="1752840"/>
                <a:gridCol w="914400"/>
                <a:gridCol w="609480"/>
                <a:gridCol w="2209680"/>
                <a:gridCol w="533520"/>
                <a:gridCol w="533520"/>
              </a:tblGrid>
              <a:tr h="152640">
                <a:tc gridSpan="3"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T4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B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456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P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ymb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cre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PA symb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cre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filin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F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pha-enol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O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inoacylase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Y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utamate dehydrogenase 1, mitochondri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U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P synthase subunit be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P5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NA-binding protein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BM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geneous nuclear ribonucleoproteins A2/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NRNPA2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socitrate dehydrogenase [NADP] cytoplas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DH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filin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FL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at shock protein beta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P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yrroline-5-carboxylate reductase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YC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enosine kin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M and SH3 domain protein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S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thanolamine-phosphate cytidylyltransfer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YT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osphatidylethanolamine-binding protein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B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iosephosphate isomer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PI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umen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U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RY domain-containing protein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tochrome b-c1 complex subunit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QCRC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uanine nucleotide-binding protein subunit beta-2-like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NB2L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ulin beta-2C cha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B2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hydroxyisobutyrate dehydrogen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BA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cyclin-binding prote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YB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s-related protein Rab-1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1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V excision repair protein RAD23 homolog 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D23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partate aminotransferase, cytoplas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T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cium-binding mitochondrial carrier prote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-phase kinase-associated protein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-hydroxyisobutyryl-CoA hydrolase, mitochondri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BC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longation factor 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SF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S protease regulatory subunit 6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C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cohol dehydrogenase [NADP+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KR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faptin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FIP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ly(rC)-binding protein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B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tochondrial-processing peptidase subunit be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MPC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talloproteinase inhibitor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P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hydrolipoyllysine-residue succinyltransfer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L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pha-soluble NSF attachment prote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P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DH dehydrogenase [ubiquinone] 1 alpha subcomplex subunit 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DUFA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erogeneous nuclear ribonucleoprotein H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NRNPH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SEC13 homolo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C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urine nucleoside phosphoryl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S acidic ribosomal protein P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PLP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Z and LIM domain protein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LIM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actin-capping protein subunit alpha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PZ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itrilase homolog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ine/threonine-protein phosphatase PP1-gamma catalytic subuni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P1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s-related protein Rab-11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11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tty acid-binding prote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BP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canopy homolog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NPY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asome subunit alpha type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A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ulin alpha-1B cha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A1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avin reduct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LVR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S protease regulatory subunit 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   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C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eavage stimulation factor 50 kDa subuni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ST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organic pyrophosphatase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osphoglycerate mutase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GAM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ibose-phosphate pyrophosphokinase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PS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iosulfate sulfurtransfer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S protease regulatory subunit 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C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uanine nucleotide-binding protein G(I)/G(S)/G(T) subunit beta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NB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11"/>
          <p:cNvSpPr/>
          <p:nvPr/>
        </p:nvSpPr>
        <p:spPr>
          <a:xfrm>
            <a:off x="1066680" y="76320"/>
            <a:ext cx="472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II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oteins deregulated 1.5-fold or more in both the cell l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9T13:21:08Z</dcterms:created>
  <dc:creator>ykulkarni</dc:creator>
  <dc:description/>
  <dc:language>en-US</dc:language>
  <cp:lastModifiedBy>David Klinke</cp:lastModifiedBy>
  <dcterms:modified xsi:type="dcterms:W3CDTF">2010-06-11T21:44:21Z</dcterms:modified>
  <cp:revision>58</cp:revision>
  <dc:subject/>
  <dc:title>Slide 1</dc:title>
</cp:coreProperties>
</file>